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9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524" y="1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84622A-E97D-F890-8036-5FA8C03647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877FBA-4A9F-359A-838F-50C460D6C0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8899CB-B811-8E53-D684-D41E968EB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5989C-B8C3-E437-9858-D80735CBE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674D24-3DB5-E6F1-49AD-4878ED96A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78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792A9-38C7-B26E-E739-AE68579CDE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F5516B-289C-9562-585A-59F24C80B9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22386B-91B9-1CD0-7009-6514B4956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AB09E3-D10C-1D55-46B2-95F4C8ADB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63F2B8-016E-2B87-D520-CBCD8EE34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9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A24182-D8B7-DC7E-8107-0515DAEFD4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4BB5D4-A496-6742-57E9-68082627B6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DF6C98-E573-5F45-D156-28A3B95C8F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57ACC0-E798-3CCC-60D4-DB5C41260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780D15-01C6-0286-EC6A-CA700B0E7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14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943306-595B-5B38-1D46-CF3857712B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AA9809-E7E3-AB5C-2F58-2D9EF9E99E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24ED3A-EBB1-6A28-F6A2-F20FA0182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A231B5-95F1-5237-4A07-4A66B5441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46F965-122D-265D-DECB-7066F79F0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730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4C8787-6E92-08E5-926C-606E0464E0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AE9D17-6A06-BCF9-7B96-BF00F8F129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F9DFAB-A64C-7CE9-DD39-CA780BA40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C000FF-7003-8CB2-AF6D-F6A855E5D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87720-8CB1-CDE8-0A16-5497FA434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982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5C2B58-D8D6-85AD-5FC6-5423BFB122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6C3502-9020-A952-B118-F9B165FC92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5804F8-4965-6BB1-F165-87DC4C7CB4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CE6E6E-4C9D-E695-6CA5-644EA0150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89B7C2-CC3B-EB2F-398B-F387975A0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C1E551-176B-6871-4B0B-44F4A6141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94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F2595-F7B5-6539-24E6-E0D6B908E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CE8B1F-5ABC-8812-216A-92EA14CE3B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A61DA0-785E-6EC9-3368-48038503FA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19A5B0-CBCB-C99F-9629-7C2DE3D608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D6EA39-AB79-86FB-C72C-05A5319E74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8D911C-A253-3A4E-D22F-D87E719A7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DF49C3-5107-CB24-E016-E0D7D1268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F4CF39-5683-9830-768E-F43FDF9A2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052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EB54B2-A8E0-FC37-D66F-8D446BB0AF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4FF266-1D0E-05D8-3DD5-0EECDE754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054DAC-6271-E992-F75A-F4831DF95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CC40BB-12BE-1A86-0DA2-DFBE62A2D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755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C73898-357B-0424-0F36-3FDD35938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7B3601-672D-F5A3-0434-F0A40E2F4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105BA9-15D7-E5BC-43E3-9125E9125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077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9EE04-FD94-D410-B8BF-B5886A646C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29E388-E874-C111-D2BD-2586436384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58FA03-B2B0-6098-7339-68399D8721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5BA37C-58ED-6432-382C-DBE05BC4B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634930-2018-2478-C04C-2CC8BE595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2ADED1-4E70-B3B0-B5E0-9D6BBBCFA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676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088CD-DF5F-7FC1-9EF1-FC7D51061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C50FA1-1FCF-6A9F-26CF-F265424700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FAC2BE-12E2-9EE9-D59A-5A12080AE1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0A95EC-E002-96EF-D8FB-472B8337A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97498A-C41E-593C-00D1-7C222B8E8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5C29AF-05D4-499C-6BBE-791C25E17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745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5AD2B8-B970-6D64-9AC6-775857BD62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76AA22-C951-4BCB-89A3-3F0A396B36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9AE8EF-A325-EB73-F866-0290E90FA0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C72380-00BF-4A73-9BF3-B84E209FC866}" type="datetimeFigureOut">
              <a:rPr lang="en-US" smtClean="0"/>
              <a:t>6/28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3D3D1B-358B-5714-8487-0924D3F3C4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8D1D2-D7B7-27A1-DFF0-284DC9CF6E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007D99-B008-4D5D-AFE7-6317F61C8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00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jpg"/><Relationship Id="rId3" Type="http://schemas.microsoft.com/office/2007/relationships/media" Target="../media/media2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4.png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3" Type="http://schemas.microsoft.com/office/2007/relationships/media" Target="../media/media5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6" Type="http://schemas.openxmlformats.org/officeDocument/2006/relationships/video" Target="../media/media6.mp4"/><Relationship Id="rId11" Type="http://schemas.openxmlformats.org/officeDocument/2006/relationships/image" Target="../media/image8.png"/><Relationship Id="rId5" Type="http://schemas.microsoft.com/office/2007/relationships/media" Target="../media/media6.mp4"/><Relationship Id="rId10" Type="http://schemas.openxmlformats.org/officeDocument/2006/relationships/image" Target="../media/image7.png"/><Relationship Id="rId4" Type="http://schemas.openxmlformats.org/officeDocument/2006/relationships/video" Target="../media/media5.mp4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10FF99-C226-5183-272E-7635B73F250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Movi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4E1D76-68A5-715F-9445-CCEB7D42C3C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b="1" dirty="0"/>
              <a:t>Synaptic Organization of Surface AMPARs Changes by Brain Region and Tauopathy</a:t>
            </a:r>
          </a:p>
          <a:p>
            <a:r>
              <a:rPr lang="en-US" dirty="0"/>
              <a:t> </a:t>
            </a:r>
          </a:p>
          <a:p>
            <a:r>
              <a:rPr lang="en-US" i="1" dirty="0"/>
              <a:t>Rohit M. Vaidya, Jiahao Zhang, Duncan Nall, Rujuta Pendharkar, Yongjae Lee, Eung Chang Kim, </a:t>
            </a:r>
            <a:r>
              <a:rPr lang="en-US" i="1" dirty="0" err="1"/>
              <a:t>Donghan</a:t>
            </a:r>
            <a:r>
              <a:rPr lang="en-US" i="1" dirty="0"/>
              <a:t> Ma, Fang Huang, Hiroshi Nonaka, Shigeki Kiyonaka, </a:t>
            </a:r>
            <a:r>
              <a:rPr lang="en-US" i="1" dirty="0" err="1"/>
              <a:t>Itaru</a:t>
            </a:r>
            <a:r>
              <a:rPr lang="en-US" i="1" dirty="0"/>
              <a:t> Hamachi, Hee Jung Chung, Paul R. Selvin*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7042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E1775186-2D34-0474-3A8A-146824859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1932" y="50970"/>
            <a:ext cx="11648135" cy="761979"/>
          </a:xfrm>
        </p:spPr>
        <p:txBody>
          <a:bodyPr>
            <a:noAutofit/>
          </a:bodyPr>
          <a:lstStyle/>
          <a:p>
            <a:pPr algn="ctr"/>
            <a:r>
              <a:rPr lang="en-US" sz="2800" b="1" u="sng" dirty="0">
                <a:solidFill>
                  <a:srgbClr val="0070C0"/>
                </a:solidFill>
              </a:rPr>
              <a:t>SM1: 3D dSTORM Imaging of Surface AMPAR and PSD-95 in 30 µm Brain Section (Cortex)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B8F1693-9582-ADDB-108A-1673A06B6978}"/>
              </a:ext>
            </a:extLst>
          </p:cNvPr>
          <p:cNvGrpSpPr/>
          <p:nvPr/>
        </p:nvGrpSpPr>
        <p:grpSpPr>
          <a:xfrm>
            <a:off x="7011520" y="889359"/>
            <a:ext cx="4621148" cy="1853419"/>
            <a:chOff x="7518859" y="673228"/>
            <a:chExt cx="4621148" cy="185341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B901067-A6FB-9CB7-3E77-83C2F51D7DAB}"/>
                </a:ext>
              </a:extLst>
            </p:cNvPr>
            <p:cNvSpPr txBox="1"/>
            <p:nvPr/>
          </p:nvSpPr>
          <p:spPr>
            <a:xfrm>
              <a:off x="7765985" y="968609"/>
              <a:ext cx="259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>
                  <a:solidFill>
                    <a:srgbClr val="00FFFF"/>
                  </a:solidFill>
                </a:rPr>
                <a:t>AMPAR – Alexa Fluor 647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CAB929E-4575-81C1-77ED-2A56662D03C2}"/>
                </a:ext>
              </a:extLst>
            </p:cNvPr>
            <p:cNvSpPr txBox="1"/>
            <p:nvPr/>
          </p:nvSpPr>
          <p:spPr>
            <a:xfrm>
              <a:off x="7518859" y="1337941"/>
              <a:ext cx="32594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>
                  <a:solidFill>
                    <a:srgbClr val="CC00CC"/>
                  </a:solidFill>
                </a:rPr>
                <a:t>Post-synapse: PSD-95-CF568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C400416-B0AF-17DC-AD05-EA2F1F8CA1F0}"/>
                </a:ext>
              </a:extLst>
            </p:cNvPr>
            <p:cNvSpPr txBox="1"/>
            <p:nvPr/>
          </p:nvSpPr>
          <p:spPr>
            <a:xfrm>
              <a:off x="8278561" y="1746503"/>
              <a:ext cx="15700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>
                  <a:solidFill>
                    <a:srgbClr val="CCFF33"/>
                  </a:solidFill>
                </a:rPr>
                <a:t>Dendrite (YFP)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FD5F424-F55C-E815-C63F-F80698752419}"/>
                </a:ext>
              </a:extLst>
            </p:cNvPr>
            <p:cNvGrpSpPr/>
            <p:nvPr/>
          </p:nvGrpSpPr>
          <p:grpSpPr>
            <a:xfrm>
              <a:off x="10833899" y="673228"/>
              <a:ext cx="1306108" cy="1853419"/>
              <a:chOff x="9722200" y="106116"/>
              <a:chExt cx="2419188" cy="3196105"/>
            </a:xfrm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9BA74024-218C-84BF-C2F1-8B7DDD852755}"/>
                  </a:ext>
                </a:extLst>
              </p:cNvPr>
              <p:cNvSpPr/>
              <p:nvPr/>
            </p:nvSpPr>
            <p:spPr>
              <a:xfrm>
                <a:off x="10580678" y="2076693"/>
                <a:ext cx="656813" cy="12255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A9FABC29-6DF9-28EB-4D39-AEDF530355A8}"/>
                  </a:ext>
                </a:extLst>
              </p:cNvPr>
              <p:cNvGrpSpPr/>
              <p:nvPr/>
            </p:nvGrpSpPr>
            <p:grpSpPr>
              <a:xfrm>
                <a:off x="9722200" y="106116"/>
                <a:ext cx="2419188" cy="3196105"/>
                <a:chOff x="9722200" y="106116"/>
                <a:chExt cx="2419188" cy="3196105"/>
              </a:xfrm>
            </p:grpSpPr>
            <p:sp>
              <p:nvSpPr>
                <p:cNvPr id="13" name="Freeform 184">
                  <a:extLst>
                    <a:ext uri="{FF2B5EF4-FFF2-40B4-BE49-F238E27FC236}">
                      <a16:creationId xmlns:a16="http://schemas.microsoft.com/office/drawing/2014/main" id="{78C7B0BD-D51D-ADE2-E49E-20D37086AA0C}"/>
                    </a:ext>
                  </a:extLst>
                </p:cNvPr>
                <p:cNvSpPr/>
                <p:nvPr/>
              </p:nvSpPr>
              <p:spPr>
                <a:xfrm rot="10800000">
                  <a:off x="10931794" y="106116"/>
                  <a:ext cx="1209594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4" name="Freeform 182">
                  <a:extLst>
                    <a:ext uri="{FF2B5EF4-FFF2-40B4-BE49-F238E27FC236}">
                      <a16:creationId xmlns:a16="http://schemas.microsoft.com/office/drawing/2014/main" id="{446182C4-4512-E93A-35C9-36A487349676}"/>
                    </a:ext>
                  </a:extLst>
                </p:cNvPr>
                <p:cNvSpPr/>
                <p:nvPr/>
              </p:nvSpPr>
              <p:spPr>
                <a:xfrm rot="10800000" flipH="1">
                  <a:off x="9722200" y="106116"/>
                  <a:ext cx="1209594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>
                    <a:highlight>
                      <a:srgbClr val="FFFF00"/>
                    </a:highlight>
                  </a:endParaRPr>
                </a:p>
              </p:txBody>
            </p:sp>
            <p:sp>
              <p:nvSpPr>
                <p:cNvPr id="15" name="Freeform 178">
                  <a:extLst>
                    <a:ext uri="{FF2B5EF4-FFF2-40B4-BE49-F238E27FC236}">
                      <a16:creationId xmlns:a16="http://schemas.microsoft.com/office/drawing/2014/main" id="{E19DDC45-61FA-9887-BDF8-E3FEAE9ECBBD}"/>
                    </a:ext>
                  </a:extLst>
                </p:cNvPr>
                <p:cNvSpPr/>
                <p:nvPr/>
              </p:nvSpPr>
              <p:spPr>
                <a:xfrm>
                  <a:off x="9722200" y="1885383"/>
                  <a:ext cx="1209595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solidFill>
                  <a:srgbClr val="FFFF00"/>
                </a:solidFill>
                <a:ln w="38100">
                  <a:solidFill>
                    <a:schemeClr val="tx1"/>
                  </a:solidFill>
                </a:ln>
                <a:effectLst>
                  <a:softEdge rad="0"/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6" name="Freeform 177">
                  <a:extLst>
                    <a:ext uri="{FF2B5EF4-FFF2-40B4-BE49-F238E27FC236}">
                      <a16:creationId xmlns:a16="http://schemas.microsoft.com/office/drawing/2014/main" id="{93F175AA-0555-86BB-12B2-CC5E30C7932B}"/>
                    </a:ext>
                  </a:extLst>
                </p:cNvPr>
                <p:cNvSpPr/>
                <p:nvPr/>
              </p:nvSpPr>
              <p:spPr>
                <a:xfrm flipH="1">
                  <a:off x="10907991" y="1885383"/>
                  <a:ext cx="1209595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solidFill>
                  <a:srgbClr val="FFFF00"/>
                </a:solidFill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7" name="Oval 16">
                  <a:extLst>
                    <a:ext uri="{FF2B5EF4-FFF2-40B4-BE49-F238E27FC236}">
                      <a16:creationId xmlns:a16="http://schemas.microsoft.com/office/drawing/2014/main" id="{6CEFD007-989F-0B45-D3C8-0E8E40C85CA5}"/>
                    </a:ext>
                  </a:extLst>
                </p:cNvPr>
                <p:cNvSpPr/>
                <p:nvPr/>
              </p:nvSpPr>
              <p:spPr>
                <a:xfrm>
                  <a:off x="11306756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8" name="Oval 17">
                  <a:extLst>
                    <a:ext uri="{FF2B5EF4-FFF2-40B4-BE49-F238E27FC236}">
                      <a16:creationId xmlns:a16="http://schemas.microsoft.com/office/drawing/2014/main" id="{57D17787-60A9-2718-43C4-C0E7CBD5466C}"/>
                    </a:ext>
                  </a:extLst>
                </p:cNvPr>
                <p:cNvSpPr/>
                <p:nvPr/>
              </p:nvSpPr>
              <p:spPr>
                <a:xfrm>
                  <a:off x="10156749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9" name="Oval 18">
                  <a:extLst>
                    <a:ext uri="{FF2B5EF4-FFF2-40B4-BE49-F238E27FC236}">
                      <a16:creationId xmlns:a16="http://schemas.microsoft.com/office/drawing/2014/main" id="{0F03F14A-2DA6-0F1F-B9C6-A1B94861DE46}"/>
                    </a:ext>
                  </a:extLst>
                </p:cNvPr>
                <p:cNvSpPr/>
                <p:nvPr/>
              </p:nvSpPr>
              <p:spPr>
                <a:xfrm>
                  <a:off x="10389668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20" name="Oval 19">
                  <a:extLst>
                    <a:ext uri="{FF2B5EF4-FFF2-40B4-BE49-F238E27FC236}">
                      <a16:creationId xmlns:a16="http://schemas.microsoft.com/office/drawing/2014/main" id="{19A6C55B-AC04-72B8-007D-951A8FBC825B}"/>
                    </a:ext>
                  </a:extLst>
                </p:cNvPr>
                <p:cNvSpPr/>
                <p:nvPr/>
              </p:nvSpPr>
              <p:spPr>
                <a:xfrm>
                  <a:off x="10580678" y="173904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21" name="Oval 20">
                  <a:extLst>
                    <a:ext uri="{FF2B5EF4-FFF2-40B4-BE49-F238E27FC236}">
                      <a16:creationId xmlns:a16="http://schemas.microsoft.com/office/drawing/2014/main" id="{DC132ADF-376C-2698-B436-7AA132CBA2BB}"/>
                    </a:ext>
                  </a:extLst>
                </p:cNvPr>
                <p:cNvSpPr/>
                <p:nvPr/>
              </p:nvSpPr>
              <p:spPr>
                <a:xfrm>
                  <a:off x="10855507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22" name="Oval 21">
                  <a:extLst>
                    <a:ext uri="{FF2B5EF4-FFF2-40B4-BE49-F238E27FC236}">
                      <a16:creationId xmlns:a16="http://schemas.microsoft.com/office/drawing/2014/main" id="{AE51B5B2-CAB1-6049-46CF-3B068344B9E5}"/>
                    </a:ext>
                  </a:extLst>
                </p:cNvPr>
                <p:cNvSpPr/>
                <p:nvPr/>
              </p:nvSpPr>
              <p:spPr>
                <a:xfrm>
                  <a:off x="11088427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23" name="Oval 22">
                  <a:extLst>
                    <a:ext uri="{FF2B5EF4-FFF2-40B4-BE49-F238E27FC236}">
                      <a16:creationId xmlns:a16="http://schemas.microsoft.com/office/drawing/2014/main" id="{D2A26488-4D9F-E838-459C-388E0381993D}"/>
                    </a:ext>
                  </a:extLst>
                </p:cNvPr>
                <p:cNvSpPr/>
                <p:nvPr/>
              </p:nvSpPr>
              <p:spPr>
                <a:xfrm>
                  <a:off x="10257584" y="2115018"/>
                  <a:ext cx="1192905" cy="429768"/>
                </a:xfrm>
                <a:prstGeom prst="ellipse">
                  <a:avLst/>
                </a:prstGeom>
                <a:solidFill>
                  <a:srgbClr val="E028D7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  <p:pic>
        <p:nvPicPr>
          <p:cNvPr id="30" name="Picture 29" descr="A yellow and black background&#10;&#10;Description automatically generated">
            <a:extLst>
              <a:ext uri="{FF2B5EF4-FFF2-40B4-BE49-F238E27FC236}">
                <a16:creationId xmlns:a16="http://schemas.microsoft.com/office/drawing/2014/main" id="{E06D074E-BD84-7412-3E34-2EA251457FB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332" y="930017"/>
            <a:ext cx="2679725" cy="5081934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D93A44E9-620E-21AC-8BBA-CB872AE3CFD5}"/>
              </a:ext>
            </a:extLst>
          </p:cNvPr>
          <p:cNvSpPr/>
          <p:nvPr/>
        </p:nvSpPr>
        <p:spPr>
          <a:xfrm>
            <a:off x="2586980" y="3152002"/>
            <a:ext cx="263214" cy="276998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519A944-041F-BF7B-3FD7-DDA72F065D1F}"/>
              </a:ext>
            </a:extLst>
          </p:cNvPr>
          <p:cNvSpPr/>
          <p:nvPr/>
        </p:nvSpPr>
        <p:spPr>
          <a:xfrm>
            <a:off x="1167246" y="2786979"/>
            <a:ext cx="312183" cy="221338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5C27783-B2D8-BF36-8C8A-CB023B48D5F0}"/>
              </a:ext>
            </a:extLst>
          </p:cNvPr>
          <p:cNvSpPr/>
          <p:nvPr/>
        </p:nvSpPr>
        <p:spPr>
          <a:xfrm>
            <a:off x="2801656" y="1766513"/>
            <a:ext cx="388324" cy="309283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CD24044-9EEF-C1FB-F4BF-8E115B5600E7}"/>
              </a:ext>
            </a:extLst>
          </p:cNvPr>
          <p:cNvSpPr txBox="1"/>
          <p:nvPr/>
        </p:nvSpPr>
        <p:spPr>
          <a:xfrm>
            <a:off x="2715594" y="1497738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107AFF5-1ABE-76AA-CD84-45AE368FE492}"/>
              </a:ext>
            </a:extLst>
          </p:cNvPr>
          <p:cNvSpPr txBox="1"/>
          <p:nvPr/>
        </p:nvSpPr>
        <p:spPr>
          <a:xfrm>
            <a:off x="1176502" y="2494293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2FC611D-162C-ED5D-0BB7-8010C80ACED1}"/>
              </a:ext>
            </a:extLst>
          </p:cNvPr>
          <p:cNvSpPr txBox="1"/>
          <p:nvPr/>
        </p:nvSpPr>
        <p:spPr>
          <a:xfrm>
            <a:off x="2586980" y="2832847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7D99EBF-F37A-1AEA-CCC7-148D7F70598E}"/>
              </a:ext>
            </a:extLst>
          </p:cNvPr>
          <p:cNvSpPr txBox="1"/>
          <p:nvPr/>
        </p:nvSpPr>
        <p:spPr>
          <a:xfrm>
            <a:off x="3693752" y="838505"/>
            <a:ext cx="336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FD47EF2-662F-1849-3309-E5625BC6B8F4}"/>
              </a:ext>
            </a:extLst>
          </p:cNvPr>
          <p:cNvSpPr txBox="1"/>
          <p:nvPr/>
        </p:nvSpPr>
        <p:spPr>
          <a:xfrm>
            <a:off x="3702545" y="2602014"/>
            <a:ext cx="336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E341F9F-81C4-546D-86AF-D3D9654425D4}"/>
              </a:ext>
            </a:extLst>
          </p:cNvPr>
          <p:cNvSpPr txBox="1"/>
          <p:nvPr/>
        </p:nvSpPr>
        <p:spPr>
          <a:xfrm>
            <a:off x="3721531" y="4134690"/>
            <a:ext cx="336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4AE6CC8-E3FF-F23A-0328-BEE23D9F3124}"/>
              </a:ext>
            </a:extLst>
          </p:cNvPr>
          <p:cNvSpPr txBox="1"/>
          <p:nvPr/>
        </p:nvSpPr>
        <p:spPr>
          <a:xfrm>
            <a:off x="7258646" y="3105835"/>
            <a:ext cx="47258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plane depth: ~15 µm from the coverslip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1C3A094-22FC-8922-2D6A-58840F093294}"/>
              </a:ext>
            </a:extLst>
          </p:cNvPr>
          <p:cNvSpPr txBox="1"/>
          <p:nvPr/>
        </p:nvSpPr>
        <p:spPr>
          <a:xfrm>
            <a:off x="7186820" y="3932170"/>
            <a:ext cx="390851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Localization Precision using INSPR PSF model:</a:t>
            </a:r>
          </a:p>
          <a:p>
            <a:r>
              <a:rPr lang="en-US" dirty="0"/>
              <a:t>Lateral: 7 nm</a:t>
            </a:r>
          </a:p>
          <a:p>
            <a:r>
              <a:rPr lang="en-US" dirty="0"/>
              <a:t>Axial: 22 nm</a:t>
            </a:r>
          </a:p>
          <a:p>
            <a:endParaRPr lang="en-US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4FCB0C8-51D5-151F-30AD-2AFAAF6D2BC2}"/>
              </a:ext>
            </a:extLst>
          </p:cNvPr>
          <p:cNvSpPr txBox="1"/>
          <p:nvPr/>
        </p:nvSpPr>
        <p:spPr>
          <a:xfrm>
            <a:off x="6142550" y="5390480"/>
            <a:ext cx="562078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The Zoomed in movies show 3D reconstruction of the selected areas. Synapses with clearly distinguished AMPAR and PSD-95 can be seen.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8B75686-DE2B-8046-F692-2F1C21FBF2EC}"/>
              </a:ext>
            </a:extLst>
          </p:cNvPr>
          <p:cNvSpPr txBox="1"/>
          <p:nvPr/>
        </p:nvSpPr>
        <p:spPr>
          <a:xfrm>
            <a:off x="501143" y="5992137"/>
            <a:ext cx="2027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cale bar: 2 µm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771201A-3DE4-D20C-C46A-331F0C06F691}"/>
              </a:ext>
            </a:extLst>
          </p:cNvPr>
          <p:cNvSpPr txBox="1"/>
          <p:nvPr/>
        </p:nvSpPr>
        <p:spPr>
          <a:xfrm>
            <a:off x="4293852" y="5966750"/>
            <a:ext cx="20276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cale bars: 0.2 µm</a:t>
            </a:r>
          </a:p>
        </p:txBody>
      </p:sp>
      <p:pic>
        <p:nvPicPr>
          <p:cNvPr id="3" name="Roi1_3Dcop-proj-avi-10fps">
            <a:hlinkClick r:id="" action="ppaction://media"/>
            <a:extLst>
              <a:ext uri="{FF2B5EF4-FFF2-40B4-BE49-F238E27FC236}">
                <a16:creationId xmlns:a16="http://schemas.microsoft.com/office/drawing/2014/main" id="{2EC42AC5-7A6D-2ED4-D09C-51B31B2C663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039210" y="988420"/>
            <a:ext cx="2382500" cy="1445123"/>
          </a:xfrm>
          <a:prstGeom prst="rect">
            <a:avLst/>
          </a:prstGeom>
        </p:spPr>
      </p:pic>
      <p:pic>
        <p:nvPicPr>
          <p:cNvPr id="6" name="Composite3D_roi2_proj-avi-10fps">
            <a:hlinkClick r:id="" action="ppaction://media"/>
            <a:extLst>
              <a:ext uri="{FF2B5EF4-FFF2-40B4-BE49-F238E27FC236}">
                <a16:creationId xmlns:a16="http://schemas.microsoft.com/office/drawing/2014/main" id="{8010BE40-3DB9-849F-332C-4621487C534F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4052862" y="2645471"/>
            <a:ext cx="2795119" cy="1197908"/>
          </a:xfrm>
          <a:prstGeom prst="rect">
            <a:avLst/>
          </a:prstGeom>
        </p:spPr>
      </p:pic>
      <p:pic>
        <p:nvPicPr>
          <p:cNvPr id="24" name="Projections of Composite-3D-roi3-proj-avi-10fps">
            <a:hlinkClick r:id="" action="ppaction://media"/>
            <a:extLst>
              <a:ext uri="{FF2B5EF4-FFF2-40B4-BE49-F238E27FC236}">
                <a16:creationId xmlns:a16="http://schemas.microsoft.com/office/drawing/2014/main" id="{C7707CE7-5162-8BF1-6D6B-ECA2DAEC86A9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4077633" y="4134690"/>
            <a:ext cx="1135305" cy="15659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42353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6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6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3600" fill="hold"/>
                                        <p:tgtEl>
                                          <p:spTgt spid="2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27" fill="hold" display="0">
                  <p:stCondLst>
                    <p:cond delay="indefinite"/>
                  </p:stCondLst>
                </p:cTn>
                <p:tgtEl>
                  <p:spTgt spid="24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2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2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Group 117">
            <a:extLst>
              <a:ext uri="{FF2B5EF4-FFF2-40B4-BE49-F238E27FC236}">
                <a16:creationId xmlns:a16="http://schemas.microsoft.com/office/drawing/2014/main" id="{0EEBCC71-21CD-ABE5-9179-FF8764C2477E}"/>
              </a:ext>
            </a:extLst>
          </p:cNvPr>
          <p:cNvGrpSpPr/>
          <p:nvPr/>
        </p:nvGrpSpPr>
        <p:grpSpPr>
          <a:xfrm>
            <a:off x="70327" y="1990219"/>
            <a:ext cx="5470105" cy="3009826"/>
            <a:chOff x="172092" y="1795569"/>
            <a:chExt cx="5140324" cy="2716458"/>
          </a:xfrm>
        </p:grpSpPr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52CAF952-5006-83CB-4462-E5FCDC007E1A}"/>
                </a:ext>
              </a:extLst>
            </p:cNvPr>
            <p:cNvGrpSpPr/>
            <p:nvPr/>
          </p:nvGrpSpPr>
          <p:grpSpPr>
            <a:xfrm>
              <a:off x="172092" y="1795569"/>
              <a:ext cx="4204559" cy="2568613"/>
              <a:chOff x="862049" y="2655936"/>
              <a:chExt cx="1476017" cy="821629"/>
            </a:xfrm>
          </p:grpSpPr>
          <p:pic>
            <p:nvPicPr>
              <p:cNvPr id="24" name="Picture 23" descr="A colorful splattered background&#10;&#10;Description automatically generated with medium confidence">
                <a:extLst>
                  <a:ext uri="{FF2B5EF4-FFF2-40B4-BE49-F238E27FC236}">
                    <a16:creationId xmlns:a16="http://schemas.microsoft.com/office/drawing/2014/main" id="{ACD2ADAC-6F6C-ADA4-66CA-F8CF7445B7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2049" y="2655936"/>
                <a:ext cx="1476017" cy="789365"/>
              </a:xfrm>
              <a:prstGeom prst="rect">
                <a:avLst/>
              </a:prstGeom>
            </p:spPr>
          </p:pic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12AD51CF-972D-2A57-55ED-B95ADEEA05FB}"/>
                  </a:ext>
                </a:extLst>
              </p:cNvPr>
              <p:cNvSpPr/>
              <p:nvPr/>
            </p:nvSpPr>
            <p:spPr>
              <a:xfrm>
                <a:off x="928950" y="3155907"/>
                <a:ext cx="160386" cy="178460"/>
              </a:xfrm>
              <a:prstGeom prst="rect">
                <a:avLst/>
              </a:prstGeom>
              <a:noFill/>
              <a:ln w="1905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56BA3909-68BC-E1B0-09F8-E702AB3DFBCA}"/>
                  </a:ext>
                </a:extLst>
              </p:cNvPr>
              <p:cNvSpPr/>
              <p:nvPr/>
            </p:nvSpPr>
            <p:spPr>
              <a:xfrm>
                <a:off x="1499509" y="2674962"/>
                <a:ext cx="166274" cy="157717"/>
              </a:xfrm>
              <a:prstGeom prst="rect">
                <a:avLst/>
              </a:prstGeom>
              <a:noFill/>
              <a:ln w="1905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325467EF-D999-D7B4-84A6-65B56A9065F6}"/>
                  </a:ext>
                </a:extLst>
              </p:cNvPr>
              <p:cNvSpPr/>
              <p:nvPr/>
            </p:nvSpPr>
            <p:spPr>
              <a:xfrm>
                <a:off x="1458615" y="3309317"/>
                <a:ext cx="192078" cy="126935"/>
              </a:xfrm>
              <a:prstGeom prst="rect">
                <a:avLst/>
              </a:prstGeom>
              <a:noFill/>
              <a:ln w="1905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155BD2B2-A987-7F9F-F4A1-AE44810E7BD5}"/>
                  </a:ext>
                </a:extLst>
              </p:cNvPr>
              <p:cNvSpPr txBox="1"/>
              <p:nvPr/>
            </p:nvSpPr>
            <p:spPr>
              <a:xfrm>
                <a:off x="1069435" y="3182925"/>
                <a:ext cx="250986" cy="2373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solidFill>
                      <a:schemeClr val="bg1"/>
                    </a:solidFill>
                  </a:rPr>
                  <a:t>1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5EE188BA-DFD1-A2C8-0420-B07095652A56}"/>
                  </a:ext>
                </a:extLst>
              </p:cNvPr>
              <p:cNvSpPr txBox="1"/>
              <p:nvPr/>
            </p:nvSpPr>
            <p:spPr>
              <a:xfrm>
                <a:off x="1638864" y="2688200"/>
                <a:ext cx="250986" cy="2373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solidFill>
                      <a:schemeClr val="bg1"/>
                    </a:solidFill>
                  </a:rPr>
                  <a:t>2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B4B07C03-6565-0C2C-954E-D6C44F863A84}"/>
                  </a:ext>
                </a:extLst>
              </p:cNvPr>
              <p:cNvSpPr txBox="1"/>
              <p:nvPr/>
            </p:nvSpPr>
            <p:spPr>
              <a:xfrm>
                <a:off x="1648923" y="3240240"/>
                <a:ext cx="250986" cy="2373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solidFill>
                      <a:schemeClr val="bg1"/>
                    </a:solidFill>
                  </a:rPr>
                  <a:t>3</a:t>
                </a:r>
              </a:p>
            </p:txBody>
          </p:sp>
        </p:grp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D0FC33A-E5B5-A936-ACD4-2F75F65B653B}"/>
                </a:ext>
              </a:extLst>
            </p:cNvPr>
            <p:cNvSpPr txBox="1"/>
            <p:nvPr/>
          </p:nvSpPr>
          <p:spPr>
            <a:xfrm>
              <a:off x="3284768" y="4235028"/>
              <a:ext cx="20276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Scale bar: 2 µm</a:t>
              </a:r>
            </a:p>
          </p:txBody>
        </p:sp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5D271880-08D6-1F04-A5CE-8AF7E2C84ECB}"/>
              </a:ext>
            </a:extLst>
          </p:cNvPr>
          <p:cNvSpPr txBox="1"/>
          <p:nvPr/>
        </p:nvSpPr>
        <p:spPr>
          <a:xfrm>
            <a:off x="4750480" y="1187132"/>
            <a:ext cx="336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2D1A53B-FA92-9EE3-A8A0-699640A698F7}"/>
              </a:ext>
            </a:extLst>
          </p:cNvPr>
          <p:cNvSpPr txBox="1"/>
          <p:nvPr/>
        </p:nvSpPr>
        <p:spPr>
          <a:xfrm>
            <a:off x="4759273" y="2879984"/>
            <a:ext cx="336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07FF8C6-4377-9A66-5C41-816963635400}"/>
              </a:ext>
            </a:extLst>
          </p:cNvPr>
          <p:cNvSpPr txBox="1"/>
          <p:nvPr/>
        </p:nvSpPr>
        <p:spPr>
          <a:xfrm>
            <a:off x="4778259" y="4483317"/>
            <a:ext cx="336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3</a:t>
            </a:r>
          </a:p>
        </p:txBody>
      </p:sp>
      <p:grpSp>
        <p:nvGrpSpPr>
          <p:cNvPr id="95" name="Group 94">
            <a:extLst>
              <a:ext uri="{FF2B5EF4-FFF2-40B4-BE49-F238E27FC236}">
                <a16:creationId xmlns:a16="http://schemas.microsoft.com/office/drawing/2014/main" id="{84F06C70-C360-31E3-827B-481DC38229C0}"/>
              </a:ext>
            </a:extLst>
          </p:cNvPr>
          <p:cNvGrpSpPr/>
          <p:nvPr/>
        </p:nvGrpSpPr>
        <p:grpSpPr>
          <a:xfrm>
            <a:off x="7011520" y="889359"/>
            <a:ext cx="4621148" cy="1853419"/>
            <a:chOff x="7518859" y="673228"/>
            <a:chExt cx="4621148" cy="1853419"/>
          </a:xfrm>
        </p:grpSpPr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0E5C1EF-7FBE-576B-2CCB-764CA76D4EB4}"/>
                </a:ext>
              </a:extLst>
            </p:cNvPr>
            <p:cNvSpPr txBox="1"/>
            <p:nvPr/>
          </p:nvSpPr>
          <p:spPr>
            <a:xfrm>
              <a:off x="7765985" y="968609"/>
              <a:ext cx="259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>
                  <a:solidFill>
                    <a:srgbClr val="00FFFF"/>
                  </a:solidFill>
                </a:rPr>
                <a:t>AMPAR – Alexa Fluor 647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2F090F84-7102-498D-9269-0FD6B437A61A}"/>
                </a:ext>
              </a:extLst>
            </p:cNvPr>
            <p:cNvSpPr txBox="1"/>
            <p:nvPr/>
          </p:nvSpPr>
          <p:spPr>
            <a:xfrm>
              <a:off x="7518859" y="1337941"/>
              <a:ext cx="33962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>
                  <a:solidFill>
                    <a:srgbClr val="CC00CC"/>
                  </a:solidFill>
                </a:rPr>
                <a:t>Post-synapse: Homer-1-CF568 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C3C4026-8FA1-7A75-4B10-2318125A5A5F}"/>
                </a:ext>
              </a:extLst>
            </p:cNvPr>
            <p:cNvSpPr txBox="1"/>
            <p:nvPr/>
          </p:nvSpPr>
          <p:spPr>
            <a:xfrm>
              <a:off x="8278561" y="1746503"/>
              <a:ext cx="15700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u="sng" dirty="0">
                  <a:solidFill>
                    <a:srgbClr val="CCFF33"/>
                  </a:solidFill>
                </a:rPr>
                <a:t>Dendrite (YFP)</a:t>
              </a:r>
            </a:p>
          </p:txBody>
        </p: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3E8CF5AA-A47A-A1DC-0B22-757EFB05B373}"/>
                </a:ext>
              </a:extLst>
            </p:cNvPr>
            <p:cNvGrpSpPr/>
            <p:nvPr/>
          </p:nvGrpSpPr>
          <p:grpSpPr>
            <a:xfrm>
              <a:off x="10833899" y="673228"/>
              <a:ext cx="1306108" cy="1853419"/>
              <a:chOff x="9722200" y="106116"/>
              <a:chExt cx="2419188" cy="3196105"/>
            </a:xfrm>
          </p:grpSpPr>
          <p:sp>
            <p:nvSpPr>
              <p:cNvPr id="100" name="Rectangle 99">
                <a:extLst>
                  <a:ext uri="{FF2B5EF4-FFF2-40B4-BE49-F238E27FC236}">
                    <a16:creationId xmlns:a16="http://schemas.microsoft.com/office/drawing/2014/main" id="{A19C03A6-F2A2-0CD3-8C85-15BE1E0D2AF3}"/>
                  </a:ext>
                </a:extLst>
              </p:cNvPr>
              <p:cNvSpPr/>
              <p:nvPr/>
            </p:nvSpPr>
            <p:spPr>
              <a:xfrm>
                <a:off x="10580678" y="2076693"/>
                <a:ext cx="656813" cy="12255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01" name="Group 100">
                <a:extLst>
                  <a:ext uri="{FF2B5EF4-FFF2-40B4-BE49-F238E27FC236}">
                    <a16:creationId xmlns:a16="http://schemas.microsoft.com/office/drawing/2014/main" id="{C56F4794-FE3B-D34E-51B7-B5C5A43E1CD3}"/>
                  </a:ext>
                </a:extLst>
              </p:cNvPr>
              <p:cNvGrpSpPr/>
              <p:nvPr/>
            </p:nvGrpSpPr>
            <p:grpSpPr>
              <a:xfrm>
                <a:off x="9722200" y="106116"/>
                <a:ext cx="2419188" cy="3196105"/>
                <a:chOff x="9722200" y="106116"/>
                <a:chExt cx="2419188" cy="3196105"/>
              </a:xfrm>
            </p:grpSpPr>
            <p:sp>
              <p:nvSpPr>
                <p:cNvPr id="102" name="Freeform 184">
                  <a:extLst>
                    <a:ext uri="{FF2B5EF4-FFF2-40B4-BE49-F238E27FC236}">
                      <a16:creationId xmlns:a16="http://schemas.microsoft.com/office/drawing/2014/main" id="{37851EB8-0DDA-02A5-6EFB-16DDF01E8E1A}"/>
                    </a:ext>
                  </a:extLst>
                </p:cNvPr>
                <p:cNvSpPr/>
                <p:nvPr/>
              </p:nvSpPr>
              <p:spPr>
                <a:xfrm rot="10800000">
                  <a:off x="10931794" y="106116"/>
                  <a:ext cx="1209594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03" name="Freeform 182">
                  <a:extLst>
                    <a:ext uri="{FF2B5EF4-FFF2-40B4-BE49-F238E27FC236}">
                      <a16:creationId xmlns:a16="http://schemas.microsoft.com/office/drawing/2014/main" id="{DB0A1EA8-DEDA-062D-AF6E-057CA0AAF567}"/>
                    </a:ext>
                  </a:extLst>
                </p:cNvPr>
                <p:cNvSpPr/>
                <p:nvPr/>
              </p:nvSpPr>
              <p:spPr>
                <a:xfrm rot="10800000" flipH="1">
                  <a:off x="9722200" y="106116"/>
                  <a:ext cx="1209594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noFill/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>
                    <a:highlight>
                      <a:srgbClr val="FFFF00"/>
                    </a:highlight>
                  </a:endParaRPr>
                </a:p>
              </p:txBody>
            </p:sp>
            <p:sp>
              <p:nvSpPr>
                <p:cNvPr id="104" name="Freeform 178">
                  <a:extLst>
                    <a:ext uri="{FF2B5EF4-FFF2-40B4-BE49-F238E27FC236}">
                      <a16:creationId xmlns:a16="http://schemas.microsoft.com/office/drawing/2014/main" id="{B424A3C2-10D9-BFE9-5676-B74F8DA9E74F}"/>
                    </a:ext>
                  </a:extLst>
                </p:cNvPr>
                <p:cNvSpPr/>
                <p:nvPr/>
              </p:nvSpPr>
              <p:spPr>
                <a:xfrm>
                  <a:off x="9722200" y="1885383"/>
                  <a:ext cx="1209595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solidFill>
                  <a:srgbClr val="FFFF00"/>
                </a:solidFill>
                <a:ln w="38100">
                  <a:solidFill>
                    <a:schemeClr val="tx1"/>
                  </a:solidFill>
                </a:ln>
                <a:effectLst>
                  <a:softEdge rad="0"/>
                </a:effec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05" name="Freeform 177">
                  <a:extLst>
                    <a:ext uri="{FF2B5EF4-FFF2-40B4-BE49-F238E27FC236}">
                      <a16:creationId xmlns:a16="http://schemas.microsoft.com/office/drawing/2014/main" id="{37932655-4994-F5CF-F48C-1B35DDE7F976}"/>
                    </a:ext>
                  </a:extLst>
                </p:cNvPr>
                <p:cNvSpPr/>
                <p:nvPr/>
              </p:nvSpPr>
              <p:spPr>
                <a:xfrm flipH="1">
                  <a:off x="10907991" y="1885383"/>
                  <a:ext cx="1209595" cy="1416838"/>
                </a:xfrm>
                <a:custGeom>
                  <a:avLst/>
                  <a:gdLst>
                    <a:gd name="connsiteX0" fmla="*/ 0 w 704626"/>
                    <a:gd name="connsiteY0" fmla="*/ 763043 h 821555"/>
                    <a:gd name="connsiteX1" fmla="*/ 505610 w 704626"/>
                    <a:gd name="connsiteY1" fmla="*/ 757664 h 821555"/>
                    <a:gd name="connsiteX2" fmla="*/ 37652 w 704626"/>
                    <a:gd name="connsiteY2" fmla="*/ 112205 h 821555"/>
                    <a:gd name="connsiteX3" fmla="*/ 704626 w 704626"/>
                    <a:gd name="connsiteY3" fmla="*/ 4629 h 821555"/>
                    <a:gd name="connsiteX0" fmla="*/ 297574 w 668713"/>
                    <a:gd name="connsiteY0" fmla="*/ 870619 h 892880"/>
                    <a:gd name="connsiteX1" fmla="*/ 469697 w 668713"/>
                    <a:gd name="connsiteY1" fmla="*/ 757664 h 892880"/>
                    <a:gd name="connsiteX2" fmla="*/ 1739 w 668713"/>
                    <a:gd name="connsiteY2" fmla="*/ 112205 h 892880"/>
                    <a:gd name="connsiteX3" fmla="*/ 668713 w 668713"/>
                    <a:gd name="connsiteY3" fmla="*/ 4629 h 892880"/>
                    <a:gd name="connsiteX0" fmla="*/ 292192 w 668710"/>
                    <a:gd name="connsiteY0" fmla="*/ 784558 h 832489"/>
                    <a:gd name="connsiteX1" fmla="*/ 469694 w 668710"/>
                    <a:gd name="connsiteY1" fmla="*/ 757664 h 832489"/>
                    <a:gd name="connsiteX2" fmla="*/ 1736 w 668710"/>
                    <a:gd name="connsiteY2" fmla="*/ 112205 h 832489"/>
                    <a:gd name="connsiteX3" fmla="*/ 668710 w 668710"/>
                    <a:gd name="connsiteY3" fmla="*/ 4629 h 832489"/>
                    <a:gd name="connsiteX0" fmla="*/ 469694 w 668710"/>
                    <a:gd name="connsiteY0" fmla="*/ 757664 h 757664"/>
                    <a:gd name="connsiteX1" fmla="*/ 1736 w 668710"/>
                    <a:gd name="connsiteY1" fmla="*/ 112205 h 757664"/>
                    <a:gd name="connsiteX2" fmla="*/ 668710 w 668710"/>
                    <a:gd name="connsiteY2" fmla="*/ 4629 h 757664"/>
                    <a:gd name="connsiteX0" fmla="*/ 469782 w 674177"/>
                    <a:gd name="connsiteY0" fmla="*/ 757664 h 757664"/>
                    <a:gd name="connsiteX1" fmla="*/ 1824 w 674177"/>
                    <a:gd name="connsiteY1" fmla="*/ 112205 h 757664"/>
                    <a:gd name="connsiteX2" fmla="*/ 674177 w 674177"/>
                    <a:gd name="connsiteY2" fmla="*/ 4629 h 757664"/>
                    <a:gd name="connsiteX0" fmla="*/ 469782 w 674177"/>
                    <a:gd name="connsiteY0" fmla="*/ 753035 h 753035"/>
                    <a:gd name="connsiteX1" fmla="*/ 1824 w 674177"/>
                    <a:gd name="connsiteY1" fmla="*/ 107576 h 753035"/>
                    <a:gd name="connsiteX2" fmla="*/ 674177 w 674177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438 w 652318"/>
                    <a:gd name="connsiteY0" fmla="*/ 753035 h 753035"/>
                    <a:gd name="connsiteX1" fmla="*/ 1480 w 652318"/>
                    <a:gd name="connsiteY1" fmla="*/ 107576 h 753035"/>
                    <a:gd name="connsiteX2" fmla="*/ 652318 w 652318"/>
                    <a:gd name="connsiteY2" fmla="*/ 0 h 753035"/>
                    <a:gd name="connsiteX0" fmla="*/ 469388 w 649002"/>
                    <a:gd name="connsiteY0" fmla="*/ 749769 h 749769"/>
                    <a:gd name="connsiteX1" fmla="*/ 1430 w 649002"/>
                    <a:gd name="connsiteY1" fmla="*/ 104310 h 749769"/>
                    <a:gd name="connsiteX2" fmla="*/ 649002 w 649002"/>
                    <a:gd name="connsiteY2" fmla="*/ 0 h 749769"/>
                    <a:gd name="connsiteX0" fmla="*/ 469388 w 649002"/>
                    <a:gd name="connsiteY0" fmla="*/ 753556 h 753556"/>
                    <a:gd name="connsiteX1" fmla="*/ 1430 w 649002"/>
                    <a:gd name="connsiteY1" fmla="*/ 108097 h 753556"/>
                    <a:gd name="connsiteX2" fmla="*/ 649002 w 649002"/>
                    <a:gd name="connsiteY2" fmla="*/ 3787 h 753556"/>
                    <a:gd name="connsiteX0" fmla="*/ 469388 w 649002"/>
                    <a:gd name="connsiteY0" fmla="*/ 750775 h 750775"/>
                    <a:gd name="connsiteX1" fmla="*/ 1430 w 649002"/>
                    <a:gd name="connsiteY1" fmla="*/ 105316 h 750775"/>
                    <a:gd name="connsiteX2" fmla="*/ 649002 w 649002"/>
                    <a:gd name="connsiteY2" fmla="*/ 1006 h 7507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649002" h="750775">
                      <a:moveTo>
                        <a:pt x="469388" y="750775"/>
                      </a:moveTo>
                      <a:cubicBezTo>
                        <a:pt x="420979" y="638716"/>
                        <a:pt x="-28506" y="230278"/>
                        <a:pt x="1430" y="105316"/>
                      </a:cubicBezTo>
                      <a:cubicBezTo>
                        <a:pt x="31366" y="-19646"/>
                        <a:pt x="332099" y="1646"/>
                        <a:pt x="649002" y="1006"/>
                      </a:cubicBezTo>
                    </a:path>
                  </a:pathLst>
                </a:custGeom>
                <a:solidFill>
                  <a:srgbClr val="FFFF00"/>
                </a:solidFill>
                <a:ln w="381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54864" tIns="27433" rIns="54864" bIns="27433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06" name="Oval 105">
                  <a:extLst>
                    <a:ext uri="{FF2B5EF4-FFF2-40B4-BE49-F238E27FC236}">
                      <a16:creationId xmlns:a16="http://schemas.microsoft.com/office/drawing/2014/main" id="{3DFA81B2-2AE2-DEAB-F01D-90FC3E7851B9}"/>
                    </a:ext>
                  </a:extLst>
                </p:cNvPr>
                <p:cNvSpPr/>
                <p:nvPr/>
              </p:nvSpPr>
              <p:spPr>
                <a:xfrm>
                  <a:off x="11306756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07" name="Oval 106">
                  <a:extLst>
                    <a:ext uri="{FF2B5EF4-FFF2-40B4-BE49-F238E27FC236}">
                      <a16:creationId xmlns:a16="http://schemas.microsoft.com/office/drawing/2014/main" id="{57F3AD95-4F7B-5AE8-AC21-9DD71D98937C}"/>
                    </a:ext>
                  </a:extLst>
                </p:cNvPr>
                <p:cNvSpPr/>
                <p:nvPr/>
              </p:nvSpPr>
              <p:spPr>
                <a:xfrm>
                  <a:off x="10156749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08" name="Oval 107">
                  <a:extLst>
                    <a:ext uri="{FF2B5EF4-FFF2-40B4-BE49-F238E27FC236}">
                      <a16:creationId xmlns:a16="http://schemas.microsoft.com/office/drawing/2014/main" id="{3CE04311-9946-EB8E-B104-A0916CB6E6D2}"/>
                    </a:ext>
                  </a:extLst>
                </p:cNvPr>
                <p:cNvSpPr/>
                <p:nvPr/>
              </p:nvSpPr>
              <p:spPr>
                <a:xfrm>
                  <a:off x="10389668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09" name="Oval 108">
                  <a:extLst>
                    <a:ext uri="{FF2B5EF4-FFF2-40B4-BE49-F238E27FC236}">
                      <a16:creationId xmlns:a16="http://schemas.microsoft.com/office/drawing/2014/main" id="{82FC1899-EFAC-6F05-0597-BC1FC2368325}"/>
                    </a:ext>
                  </a:extLst>
                </p:cNvPr>
                <p:cNvSpPr/>
                <p:nvPr/>
              </p:nvSpPr>
              <p:spPr>
                <a:xfrm>
                  <a:off x="10580678" y="173904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10" name="Oval 109">
                  <a:extLst>
                    <a:ext uri="{FF2B5EF4-FFF2-40B4-BE49-F238E27FC236}">
                      <a16:creationId xmlns:a16="http://schemas.microsoft.com/office/drawing/2014/main" id="{1E96A655-99DF-C511-79C4-ED9B4DC8E66E}"/>
                    </a:ext>
                  </a:extLst>
                </p:cNvPr>
                <p:cNvSpPr/>
                <p:nvPr/>
              </p:nvSpPr>
              <p:spPr>
                <a:xfrm>
                  <a:off x="10855507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11" name="Oval 110">
                  <a:extLst>
                    <a:ext uri="{FF2B5EF4-FFF2-40B4-BE49-F238E27FC236}">
                      <a16:creationId xmlns:a16="http://schemas.microsoft.com/office/drawing/2014/main" id="{C186FFC4-D0B9-AA39-51CC-1754E4378EBC}"/>
                    </a:ext>
                  </a:extLst>
                </p:cNvPr>
                <p:cNvSpPr/>
                <p:nvPr/>
              </p:nvSpPr>
              <p:spPr>
                <a:xfrm>
                  <a:off x="11088427" y="1776163"/>
                  <a:ext cx="115425" cy="300530"/>
                </a:xfrm>
                <a:prstGeom prst="ellipse">
                  <a:avLst/>
                </a:prstGeom>
                <a:solidFill>
                  <a:srgbClr val="00FFFF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81" dirty="0"/>
                </a:p>
              </p:txBody>
            </p:sp>
            <p:sp>
              <p:nvSpPr>
                <p:cNvPr id="112" name="Oval 111">
                  <a:extLst>
                    <a:ext uri="{FF2B5EF4-FFF2-40B4-BE49-F238E27FC236}">
                      <a16:creationId xmlns:a16="http://schemas.microsoft.com/office/drawing/2014/main" id="{046D4559-7325-E943-837F-8B52029E8A50}"/>
                    </a:ext>
                  </a:extLst>
                </p:cNvPr>
                <p:cNvSpPr/>
                <p:nvPr/>
              </p:nvSpPr>
              <p:spPr>
                <a:xfrm>
                  <a:off x="10257584" y="2115018"/>
                  <a:ext cx="1192905" cy="429768"/>
                </a:xfrm>
                <a:prstGeom prst="ellipse">
                  <a:avLst/>
                </a:prstGeom>
                <a:solidFill>
                  <a:srgbClr val="E028D7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</p:grpSp>
      <p:sp>
        <p:nvSpPr>
          <p:cNvPr id="113" name="TextBox 112">
            <a:extLst>
              <a:ext uri="{FF2B5EF4-FFF2-40B4-BE49-F238E27FC236}">
                <a16:creationId xmlns:a16="http://schemas.microsoft.com/office/drawing/2014/main" id="{D7BD59F0-5BD3-5EFD-C84A-E7915931FEDA}"/>
              </a:ext>
            </a:extLst>
          </p:cNvPr>
          <p:cNvSpPr txBox="1"/>
          <p:nvPr/>
        </p:nvSpPr>
        <p:spPr>
          <a:xfrm>
            <a:off x="7258646" y="3105835"/>
            <a:ext cx="47258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plane depth: ~18 µm from the coverslip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67F5EEC3-CCD2-14D6-BBE8-19C5AB9E2CC6}"/>
              </a:ext>
            </a:extLst>
          </p:cNvPr>
          <p:cNvSpPr txBox="1"/>
          <p:nvPr/>
        </p:nvSpPr>
        <p:spPr>
          <a:xfrm>
            <a:off x="7186820" y="3932170"/>
            <a:ext cx="390851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Localization Precision using INSPR PSF model:</a:t>
            </a:r>
          </a:p>
          <a:p>
            <a:r>
              <a:rPr lang="en-US" dirty="0"/>
              <a:t>Lateral: 6 nm</a:t>
            </a:r>
          </a:p>
          <a:p>
            <a:r>
              <a:rPr lang="en-US" dirty="0"/>
              <a:t>Axial: 20 nm</a:t>
            </a:r>
          </a:p>
          <a:p>
            <a:endParaRPr lang="en-US" dirty="0"/>
          </a:p>
        </p:txBody>
      </p:sp>
      <p:pic>
        <p:nvPicPr>
          <p:cNvPr id="115" name="Projections of Composite-1-3D-1-avi-10fps">
            <a:hlinkClick r:id="" action="ppaction://media"/>
            <a:extLst>
              <a:ext uri="{FF2B5EF4-FFF2-40B4-BE49-F238E27FC236}">
                <a16:creationId xmlns:a16="http://schemas.microsoft.com/office/drawing/2014/main" id="{ABFD58D5-7038-C159-E33D-00919CAA0EC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5102455" y="1302576"/>
            <a:ext cx="1752304" cy="1395903"/>
          </a:xfrm>
          <a:prstGeom prst="rect">
            <a:avLst/>
          </a:prstGeom>
        </p:spPr>
      </p:pic>
      <p:pic>
        <p:nvPicPr>
          <p:cNvPr id="116" name="Projections of Composite-1-3D-3-avi-10fps">
            <a:hlinkClick r:id="" action="ppaction://media"/>
            <a:extLst>
              <a:ext uri="{FF2B5EF4-FFF2-40B4-BE49-F238E27FC236}">
                <a16:creationId xmlns:a16="http://schemas.microsoft.com/office/drawing/2014/main" id="{6A10EADB-EB08-12A9-5418-FC5FD808BCF6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5121850" y="3004544"/>
            <a:ext cx="1738881" cy="1266899"/>
          </a:xfrm>
          <a:prstGeom prst="rect">
            <a:avLst/>
          </a:prstGeom>
        </p:spPr>
      </p:pic>
      <p:pic>
        <p:nvPicPr>
          <p:cNvPr id="117" name="Projections of Composite-1-3D-2-1-avi-10fps">
            <a:hlinkClick r:id="" action="ppaction://media"/>
            <a:extLst>
              <a:ext uri="{FF2B5EF4-FFF2-40B4-BE49-F238E27FC236}">
                <a16:creationId xmlns:a16="http://schemas.microsoft.com/office/drawing/2014/main" id="{FCF6062A-3D7C-2865-FCD6-5CA28645ABC3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5121850" y="4577508"/>
            <a:ext cx="1361438" cy="1663980"/>
          </a:xfrm>
          <a:prstGeom prst="rect">
            <a:avLst/>
          </a:prstGeom>
        </p:spPr>
      </p:pic>
      <p:sp>
        <p:nvSpPr>
          <p:cNvPr id="119" name="Title 1">
            <a:extLst>
              <a:ext uri="{FF2B5EF4-FFF2-40B4-BE49-F238E27FC236}">
                <a16:creationId xmlns:a16="http://schemas.microsoft.com/office/drawing/2014/main" id="{B84B14E7-837C-16DD-99DC-C955A0709C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1932" y="50971"/>
            <a:ext cx="11648135" cy="838386"/>
          </a:xfrm>
        </p:spPr>
        <p:txBody>
          <a:bodyPr>
            <a:noAutofit/>
          </a:bodyPr>
          <a:lstStyle/>
          <a:p>
            <a:pPr algn="ctr"/>
            <a:r>
              <a:rPr lang="en-US" sz="2800" b="1" u="sng" dirty="0">
                <a:solidFill>
                  <a:srgbClr val="0070C0"/>
                </a:solidFill>
              </a:rPr>
              <a:t>SM2: 3D dSTORM Imaging of Surface AMPAR and Homer-1 in 30 µm Brain Section (Cortex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71839D-4B41-F3ED-0F5E-11D241D3E9A4}"/>
              </a:ext>
            </a:extLst>
          </p:cNvPr>
          <p:cNvSpPr txBox="1"/>
          <p:nvPr/>
        </p:nvSpPr>
        <p:spPr>
          <a:xfrm>
            <a:off x="6741066" y="5356879"/>
            <a:ext cx="562078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The Zoomed in movies show 3D reconstruction of the selected areas. Synapses with clearly distinguished AMPAR and PSD-95 can be seen.</a:t>
            </a:r>
          </a:p>
        </p:txBody>
      </p:sp>
    </p:spTree>
    <p:extLst>
      <p:ext uri="{BB962C8B-B14F-4D97-AF65-F5344CB8AC3E}">
        <p14:creationId xmlns:p14="http://schemas.microsoft.com/office/powerpoint/2010/main" val="41047502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600" fill="hold"/>
                                        <p:tgtEl>
                                          <p:spTgt spid="1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600" fill="hold"/>
                                        <p:tgtEl>
                                          <p:spTgt spid="1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3600" fill="hold"/>
                                        <p:tgtEl>
                                          <p:spTgt spid="1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115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11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1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5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116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1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1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6"/>
                  </p:tgtEl>
                </p:cond>
              </p:nextCondLst>
            </p:seq>
            <p:video>
              <p:cMediaNode vol="80000">
                <p:cTn id="27" fill="hold" display="0">
                  <p:stCondLst>
                    <p:cond delay="indefinite"/>
                  </p:stCondLst>
                </p:cTn>
                <p:tgtEl>
                  <p:spTgt spid="117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1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1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7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242</Words>
  <Application>Microsoft Office PowerPoint</Application>
  <PresentationFormat>Widescreen</PresentationFormat>
  <Paragraphs>37</Paragraphs>
  <Slides>3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Supplementary Movies</vt:lpstr>
      <vt:lpstr>SM1: 3D dSTORM Imaging of Surface AMPAR and PSD-95 in 30 µm Brain Section (Cortex)</vt:lpstr>
      <vt:lpstr>SM2: 3D dSTORM Imaging of Surface AMPAR and Homer-1 in 30 µm Brain Section (Cortex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aidya, Rohit Mohan</dc:creator>
  <cp:lastModifiedBy>Vaidya, Rohit Mohan</cp:lastModifiedBy>
  <cp:revision>11</cp:revision>
  <dcterms:created xsi:type="dcterms:W3CDTF">2024-11-25T06:33:54Z</dcterms:created>
  <dcterms:modified xsi:type="dcterms:W3CDTF">2026-06-28T05:47:48Z</dcterms:modified>
</cp:coreProperties>
</file>